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7"/>
  </p:notesMasterIdLst>
  <p:sldIdLst>
    <p:sldId id="319" r:id="rId2"/>
    <p:sldId id="266" r:id="rId3"/>
    <p:sldId id="277" r:id="rId4"/>
    <p:sldId id="260" r:id="rId5"/>
    <p:sldId id="259" r:id="rId6"/>
    <p:sldId id="315" r:id="rId7"/>
    <p:sldId id="272" r:id="rId8"/>
    <p:sldId id="294" r:id="rId9"/>
    <p:sldId id="304" r:id="rId10"/>
    <p:sldId id="303" r:id="rId11"/>
    <p:sldId id="305" r:id="rId12"/>
    <p:sldId id="296" r:id="rId13"/>
    <p:sldId id="293" r:id="rId14"/>
    <p:sldId id="302" r:id="rId15"/>
    <p:sldId id="307" r:id="rId1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D7F0"/>
    <a:srgbClr val="9081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02" autoAdjust="0"/>
    <p:restoredTop sz="94660"/>
  </p:normalViewPr>
  <p:slideViewPr>
    <p:cSldViewPr snapToGrid="0">
      <p:cViewPr varScale="1">
        <p:scale>
          <a:sx n="48" d="100"/>
          <a:sy n="48" d="100"/>
        </p:scale>
        <p:origin x="1464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38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75BB48-4A7D-4B30-BB73-72D36056CFF5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B5DC5B-116E-4998-BEAD-1D4FA8B5B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034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137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710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861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9906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73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724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45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035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598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7931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486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8C456-EC79-4CC3-B7A8-A2CA98825763}" type="datetimeFigureOut">
              <a:rPr lang="en-GB" smtClean="0"/>
              <a:t>11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3A169-3AA2-4210-A17D-5C34A6370C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2557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3" Type="http://schemas.openxmlformats.org/officeDocument/2006/relationships/image" Target="../media/image8.png"/><Relationship Id="rId21" Type="http://schemas.openxmlformats.org/officeDocument/2006/relationships/image" Target="../media/image26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" Type="http://schemas.openxmlformats.org/officeDocument/2006/relationships/image" Target="../media/image7.png"/><Relationship Id="rId16" Type="http://schemas.openxmlformats.org/officeDocument/2006/relationships/image" Target="../media/image21.png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10" Type="http://schemas.openxmlformats.org/officeDocument/2006/relationships/image" Target="../media/image15.png"/><Relationship Id="rId19" Type="http://schemas.openxmlformats.org/officeDocument/2006/relationships/image" Target="../media/image24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Relationship Id="rId22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5205193"/>
              </p:ext>
            </p:extLst>
          </p:nvPr>
        </p:nvGraphicFramePr>
        <p:xfrm>
          <a:off x="427038" y="2423296"/>
          <a:ext cx="5915025" cy="43116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0517">
                  <a:extLst>
                    <a:ext uri="{9D8B030D-6E8A-4147-A177-3AD203B41FA5}">
                      <a16:colId xmlns:a16="http://schemas.microsoft.com/office/drawing/2014/main" val="3374357623"/>
                    </a:ext>
                  </a:extLst>
                </a:gridCol>
                <a:gridCol w="1448952">
                  <a:extLst>
                    <a:ext uri="{9D8B030D-6E8A-4147-A177-3AD203B41FA5}">
                      <a16:colId xmlns:a16="http://schemas.microsoft.com/office/drawing/2014/main" val="2594376061"/>
                    </a:ext>
                  </a:extLst>
                </a:gridCol>
                <a:gridCol w="1164664">
                  <a:extLst>
                    <a:ext uri="{9D8B030D-6E8A-4147-A177-3AD203B41FA5}">
                      <a16:colId xmlns:a16="http://schemas.microsoft.com/office/drawing/2014/main" val="3556138709"/>
                    </a:ext>
                  </a:extLst>
                </a:gridCol>
                <a:gridCol w="1201346">
                  <a:extLst>
                    <a:ext uri="{9D8B030D-6E8A-4147-A177-3AD203B41FA5}">
                      <a16:colId xmlns:a16="http://schemas.microsoft.com/office/drawing/2014/main" val="2514832605"/>
                    </a:ext>
                  </a:extLst>
                </a:gridCol>
                <a:gridCol w="889546">
                  <a:extLst>
                    <a:ext uri="{9D8B030D-6E8A-4147-A177-3AD203B41FA5}">
                      <a16:colId xmlns:a16="http://schemas.microsoft.com/office/drawing/2014/main" val="2749530404"/>
                    </a:ext>
                  </a:extLst>
                </a:gridCol>
              </a:tblGrid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Antibody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err="1" smtClean="0">
                          <a:effectLst/>
                        </a:rPr>
                        <a:t>Fluorochrom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smtClean="0">
                          <a:effectLst/>
                        </a:rPr>
                        <a:t>Company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smtClean="0">
                          <a:effectLst/>
                        </a:rPr>
                        <a:t>Cat.</a:t>
                      </a:r>
                      <a:r>
                        <a:rPr lang="en-GB" sz="1200" b="1" u="none" strike="noStrike" baseline="0" dirty="0" smtClean="0">
                          <a:effectLst/>
                        </a:rPr>
                        <a:t> N</a:t>
                      </a:r>
                      <a:r>
                        <a:rPr lang="en-GB" sz="1200" b="1" u="none" strike="noStrike" dirty="0" smtClean="0">
                          <a:effectLst/>
                        </a:rPr>
                        <a:t>o.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 smtClean="0">
                          <a:effectLst/>
                        </a:rPr>
                        <a:t>Dilution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838794262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CD1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AP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745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5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398967617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CD1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altag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MHCD14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173435088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CD2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eBioscienc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1-0298-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3419569674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CD3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PerCP-eFluor71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eBioscienc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6-0394-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891750072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FI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5478</a:t>
                      </a:r>
                      <a:endParaRPr lang="en-GB" sz="1200" b="0" i="0" u="none" strike="noStrike">
                        <a:solidFill>
                          <a:srgbClr val="404041"/>
                        </a:solidFill>
                        <a:effectLst/>
                        <a:latin typeface="Helvetica" panose="020B0604020202020204" pitchFamily="34" charset="0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3144944139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APC-eFluor78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eBioscienc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7-0459-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466675413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a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P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95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112831772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b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FI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B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54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4205210941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P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B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60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046075086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PE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B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55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479198846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AP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err="1">
                          <a:effectLst/>
                        </a:rPr>
                        <a:t>Miltenyi</a:t>
                      </a:r>
                      <a:r>
                        <a:rPr lang="en-GB" sz="1200" u="none" strike="noStrike" dirty="0">
                          <a:effectLst/>
                        </a:rPr>
                        <a:t> </a:t>
                      </a:r>
                      <a:r>
                        <a:rPr lang="en-GB" sz="1200" u="none" strike="noStrike" dirty="0" err="1">
                          <a:effectLst/>
                        </a:rPr>
                        <a:t>Biote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30-097-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352632573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49f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B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555735</a:t>
                      </a:r>
                      <a:endParaRPr lang="en-GB" sz="1200" b="0" i="0" u="none" strike="noStrike">
                        <a:solidFill>
                          <a:srgbClr val="404041"/>
                        </a:solidFill>
                        <a:effectLst/>
                        <a:latin typeface="Helvetica" panose="020B0604020202020204" pitchFamily="34" charset="0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3563373204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5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AP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err="1">
                          <a:effectLst/>
                        </a:rPr>
                        <a:t>Miltenyi</a:t>
                      </a:r>
                      <a:r>
                        <a:rPr lang="en-GB" sz="1200" u="none" strike="noStrike" dirty="0">
                          <a:effectLst/>
                        </a:rPr>
                        <a:t> </a:t>
                      </a:r>
                      <a:r>
                        <a:rPr lang="en-GB" sz="1200" u="none" strike="noStrike" dirty="0" err="1">
                          <a:effectLst/>
                        </a:rPr>
                        <a:t>Biote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30-113-3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5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925609086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7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err="1">
                          <a:effectLst/>
                        </a:rPr>
                        <a:t>Biolegen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410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713296239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7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V5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BD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6319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364425111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9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PE-Vio77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Miltenyi Biote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30-090-29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757203026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AP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Miltenyi Biote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30-094-92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1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937515413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1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R&amp;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FAB932F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/5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616176459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1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P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5926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/5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921282817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CD27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P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57196</a:t>
                      </a:r>
                      <a:endParaRPr lang="en-GB" sz="1200" b="0" i="0" u="none" strike="noStrike" dirty="0">
                        <a:solidFill>
                          <a:srgbClr val="404041"/>
                        </a:solidFill>
                        <a:effectLst/>
                        <a:latin typeface="Helvetica" panose="020B0604020202020204" pitchFamily="34" charset="0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/5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380749988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HLA-A,B,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PE-Vio-77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Miltenyi Biote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30-120-43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/10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1424649430"/>
                  </a:ext>
                </a:extLst>
              </a:tr>
              <a:tr h="18341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HLA-DP,CP,DQ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FIT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BD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55555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/10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MT"/>
                      </a:endParaRPr>
                    </a:p>
                  </a:txBody>
                  <a:tcPr marL="4585" marR="4585" marT="4585" marB="0" anchor="b"/>
                </a:tc>
                <a:extLst>
                  <a:ext uri="{0D108BD9-81ED-4DB2-BD59-A6C34878D82A}">
                    <a16:rowId xmlns:a16="http://schemas.microsoft.com/office/drawing/2014/main" val="2079826010"/>
                  </a:ext>
                </a:extLst>
              </a:tr>
            </a:tbl>
          </a:graphicData>
        </a:graphic>
      </p:graphicFrame>
      <p:sp>
        <p:nvSpPr>
          <p:cNvPr id="3" name="TextBox 72">
            <a:extLst>
              <a:ext uri="{FF2B5EF4-FFF2-40B4-BE49-F238E27FC236}">
                <a16:creationId xmlns:a16="http://schemas.microsoft.com/office/drawing/2014/main" id="{598D48B9-6F74-E243-A0CC-17A7A31B5D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875" y="6980401"/>
            <a:ext cx="50542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/>
            <a:r>
              <a:rPr lang="en-GB" altLang="en-US" sz="1800" dirty="0" smtClean="0">
                <a:latin typeface="+mn-lt"/>
              </a:rPr>
              <a:t>Supplementary Table 1.</a:t>
            </a:r>
            <a:endParaRPr lang="en-GB" alt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2375265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r="14608"/>
          <a:stretch/>
        </p:blipFill>
        <p:spPr>
          <a:xfrm>
            <a:off x="559740" y="835959"/>
            <a:ext cx="5586618" cy="3181743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/>
          <a:srcRect l="86777" t="8501" b="21311"/>
          <a:stretch/>
        </p:blipFill>
        <p:spPr>
          <a:xfrm>
            <a:off x="559740" y="1891663"/>
            <a:ext cx="892661" cy="2304375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19" name="TextBox 18"/>
          <p:cNvSpPr txBox="1"/>
          <p:nvPr/>
        </p:nvSpPr>
        <p:spPr>
          <a:xfrm>
            <a:off x="2773173" y="435587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hMS &gt; </a:t>
            </a:r>
            <a:r>
              <a:rPr lang="en-GB" sz="1600" dirty="0" err="1" smtClean="0"/>
              <a:t>hBM</a:t>
            </a:r>
            <a:r>
              <a:rPr lang="en-GB" sz="1600" dirty="0" smtClean="0"/>
              <a:t> MSC</a:t>
            </a:r>
            <a:endParaRPr lang="en-GB" sz="1600" dirty="0"/>
          </a:p>
        </p:txBody>
      </p:sp>
      <p:sp>
        <p:nvSpPr>
          <p:cNvPr id="2" name="TextBox 1"/>
          <p:cNvSpPr txBox="1"/>
          <p:nvPr/>
        </p:nvSpPr>
        <p:spPr>
          <a:xfrm>
            <a:off x="376037" y="8330382"/>
            <a:ext cx="2696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9.  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79136" y="367081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.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76036" y="4414134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r>
              <a:rPr lang="en-GB" dirty="0" smtClean="0"/>
              <a:t>.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2773173" y="4398363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 smtClean="0"/>
              <a:t>hMS</a:t>
            </a:r>
            <a:r>
              <a:rPr lang="en-GB" sz="1600" dirty="0" smtClean="0"/>
              <a:t> &lt; </a:t>
            </a:r>
            <a:r>
              <a:rPr lang="en-GB" sz="1600" dirty="0" err="1" smtClean="0"/>
              <a:t>hBM</a:t>
            </a:r>
            <a:r>
              <a:rPr lang="en-GB" sz="1600" dirty="0" smtClean="0"/>
              <a:t> MSC</a:t>
            </a:r>
            <a:endParaRPr lang="en-GB" sz="1600" dirty="0"/>
          </a:p>
        </p:txBody>
      </p:sp>
      <p:grpSp>
        <p:nvGrpSpPr>
          <p:cNvPr id="10" name="Group 9"/>
          <p:cNvGrpSpPr/>
          <p:nvPr/>
        </p:nvGrpSpPr>
        <p:grpSpPr>
          <a:xfrm>
            <a:off x="559740" y="4955013"/>
            <a:ext cx="5586618" cy="3005151"/>
            <a:chOff x="-1129349" y="2395180"/>
            <a:chExt cx="9116697" cy="511563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129349" y="2395180"/>
              <a:ext cx="9116697" cy="5115639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353871" y="2426830"/>
              <a:ext cx="1286054" cy="33437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05935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7152" y="5026967"/>
            <a:ext cx="4530748" cy="376400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550" y="303616"/>
            <a:ext cx="4452050" cy="4381586"/>
          </a:xfrm>
          <a:prstGeom prst="rect">
            <a:avLst/>
          </a:prstGeom>
          <a:ln>
            <a:noFill/>
          </a:ln>
        </p:spPr>
      </p:pic>
      <p:sp>
        <p:nvSpPr>
          <p:cNvPr id="19" name="TextBox 18"/>
          <p:cNvSpPr txBox="1"/>
          <p:nvPr/>
        </p:nvSpPr>
        <p:spPr>
          <a:xfrm>
            <a:off x="1246522" y="376395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hMS &gt; </a:t>
            </a:r>
            <a:r>
              <a:rPr lang="en-GB" sz="1600" dirty="0" err="1" smtClean="0"/>
              <a:t>hBM</a:t>
            </a:r>
            <a:r>
              <a:rPr lang="en-GB" sz="1600" dirty="0" smtClean="0"/>
              <a:t> MSC</a:t>
            </a:r>
            <a:endParaRPr lang="en-GB" sz="1600" dirty="0"/>
          </a:p>
        </p:txBody>
      </p:sp>
      <p:sp>
        <p:nvSpPr>
          <p:cNvPr id="2" name="TextBox 1"/>
          <p:cNvSpPr txBox="1"/>
          <p:nvPr/>
        </p:nvSpPr>
        <p:spPr>
          <a:xfrm>
            <a:off x="245733" y="9098441"/>
            <a:ext cx="2726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10.  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79136" y="367081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.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488498" y="5149652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r>
              <a:rPr lang="en-GB" dirty="0" smtClean="0"/>
              <a:t>.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1317644" y="5149652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 smtClean="0"/>
              <a:t>hMS</a:t>
            </a:r>
            <a:r>
              <a:rPr lang="en-GB" sz="1600" dirty="0" smtClean="0"/>
              <a:t> &lt; </a:t>
            </a:r>
            <a:r>
              <a:rPr lang="en-GB" sz="1600" dirty="0" err="1" smtClean="0"/>
              <a:t>hBM</a:t>
            </a:r>
            <a:r>
              <a:rPr lang="en-GB" sz="1600" dirty="0" smtClean="0"/>
              <a:t> MSC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495620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9740" y="8529615"/>
            <a:ext cx="6021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 11.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2F6AC3-A4F7-704A-B2E2-96E6525EFFEB}"/>
              </a:ext>
            </a:extLst>
          </p:cNvPr>
          <p:cNvSpPr txBox="1"/>
          <p:nvPr/>
        </p:nvSpPr>
        <p:spPr>
          <a:xfrm>
            <a:off x="490236" y="3931166"/>
            <a:ext cx="439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I.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90236" y="7548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</a:t>
            </a:r>
            <a:r>
              <a:rPr lang="en-GB" dirty="0" smtClean="0"/>
              <a:t>.</a:t>
            </a:r>
            <a:endParaRPr lang="en-GB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/>
          <a:srcRect r="13656"/>
          <a:stretch/>
        </p:blipFill>
        <p:spPr>
          <a:xfrm>
            <a:off x="873355" y="939508"/>
            <a:ext cx="5251147" cy="2991658"/>
          </a:xfrm>
          <a:prstGeom prst="rect">
            <a:avLst/>
          </a:prstGeom>
          <a:ln>
            <a:noFill/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86344" t="16890" r="-317" b="26618"/>
          <a:stretch/>
        </p:blipFill>
        <p:spPr>
          <a:xfrm>
            <a:off x="1225550" y="2134063"/>
            <a:ext cx="853344" cy="1696993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1645" t="984" r="2738"/>
          <a:stretch/>
        </p:blipFill>
        <p:spPr>
          <a:xfrm>
            <a:off x="1123095" y="3931166"/>
            <a:ext cx="4895216" cy="4498339"/>
          </a:xfrm>
          <a:prstGeom prst="rect">
            <a:avLst/>
          </a:prstGeom>
          <a:ln>
            <a:noFill/>
          </a:ln>
        </p:spPr>
      </p:pic>
      <p:sp>
        <p:nvSpPr>
          <p:cNvPr id="9" name="TextBox 8"/>
          <p:cNvSpPr txBox="1"/>
          <p:nvPr/>
        </p:nvSpPr>
        <p:spPr>
          <a:xfrm>
            <a:off x="2815560" y="420011"/>
            <a:ext cx="1432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[</a:t>
            </a:r>
            <a:r>
              <a:rPr lang="en-GB" dirty="0" err="1" smtClean="0"/>
              <a:t>hMS</a:t>
            </a:r>
            <a:r>
              <a:rPr lang="en-GB" dirty="0" smtClean="0"/>
              <a:t> </a:t>
            </a:r>
            <a:r>
              <a:rPr lang="en-GB" dirty="0"/>
              <a:t>&gt;</a:t>
            </a:r>
            <a:r>
              <a:rPr lang="en-GB" dirty="0" smtClean="0"/>
              <a:t> hESC]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899440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563" y="754178"/>
            <a:ext cx="5411587" cy="263183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14563" y="7101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.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796717" y="7869501"/>
            <a:ext cx="2988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     12.  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614563" y="3496619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I.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677" y="3496619"/>
            <a:ext cx="4515355" cy="4081495"/>
          </a:xfrm>
          <a:prstGeom prst="rect">
            <a:avLst/>
          </a:prstGeom>
          <a:ln>
            <a:noFill/>
          </a:ln>
        </p:spPr>
      </p:pic>
      <p:sp>
        <p:nvSpPr>
          <p:cNvPr id="8" name="TextBox 7"/>
          <p:cNvSpPr txBox="1"/>
          <p:nvPr/>
        </p:nvSpPr>
        <p:spPr>
          <a:xfrm>
            <a:off x="2822024" y="384846"/>
            <a:ext cx="1895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[</a:t>
            </a:r>
            <a:r>
              <a:rPr lang="en-GB" dirty="0" err="1" smtClean="0"/>
              <a:t>hMS</a:t>
            </a:r>
            <a:r>
              <a:rPr lang="en-GB" dirty="0" smtClean="0"/>
              <a:t> </a:t>
            </a:r>
            <a:r>
              <a:rPr lang="en-GB" dirty="0"/>
              <a:t>&gt;</a:t>
            </a:r>
            <a:r>
              <a:rPr lang="en-GB" dirty="0" smtClean="0"/>
              <a:t> </a:t>
            </a:r>
            <a:r>
              <a:rPr lang="en-GB" dirty="0" err="1" smtClean="0"/>
              <a:t>hBM</a:t>
            </a:r>
            <a:r>
              <a:rPr lang="en-GB" dirty="0" smtClean="0"/>
              <a:t> MSC]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706468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3981" y="1072834"/>
            <a:ext cx="3369061" cy="528035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443578" y="6534114"/>
            <a:ext cx="16225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: 25</a:t>
            </a:r>
          </a:p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eractions: 88</a:t>
            </a:r>
          </a:p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ected Interactions: 15 (p=0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443578" y="613195"/>
            <a:ext cx="1945789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  <a:spcAft>
                <a:spcPts val="600"/>
              </a:spcAft>
            </a:pPr>
            <a:r>
              <a:rPr lang="en-GB" sz="1200" dirty="0" err="1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S</a:t>
            </a:r>
            <a:r>
              <a:rPr lang="en-GB" sz="1200" dirty="0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gt; </a:t>
            </a:r>
            <a:r>
              <a:rPr lang="en-GB" sz="1200" dirty="0" err="1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SC</a:t>
            </a:r>
            <a:r>
              <a:rPr lang="en-GB" sz="1200" dirty="0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p 25 RNA</a:t>
            </a:r>
            <a:endParaRPr lang="en-GB" sz="1200" dirty="0">
              <a:solidFill>
                <a:prstClr val="black">
                  <a:lumMod val="75000"/>
                  <a:lumOff val="25000"/>
                </a:prst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98831" y="7325106"/>
            <a:ext cx="2593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3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79898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341" y="1042630"/>
            <a:ext cx="5467859" cy="46007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722323" y="5643372"/>
            <a:ext cx="20313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: 37 </a:t>
            </a:r>
          </a:p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eractions: 99</a:t>
            </a:r>
          </a:p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xpected Interactions: 40 (p= 3.11e-15) 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894975" y="568745"/>
            <a:ext cx="2245551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  <a:spcAft>
                <a:spcPts val="600"/>
              </a:spcAft>
            </a:pPr>
            <a:r>
              <a:rPr lang="en-GB" sz="1200" dirty="0" err="1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S</a:t>
            </a:r>
            <a:r>
              <a:rPr lang="en-GB" sz="1200" dirty="0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gt; </a:t>
            </a:r>
            <a:r>
              <a:rPr lang="en-GB" sz="1200" dirty="0" err="1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M</a:t>
            </a:r>
            <a:r>
              <a:rPr lang="en-GB" sz="1200" dirty="0" smtClean="0">
                <a:solidFill>
                  <a:prstClr val="black">
                    <a:lumMod val="75000"/>
                    <a:lumOff val="2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SC Top 50 RNA</a:t>
            </a:r>
            <a:endParaRPr lang="en-GB" sz="1200" dirty="0">
              <a:solidFill>
                <a:prstClr val="black">
                  <a:lumMod val="75000"/>
                  <a:lumOff val="25000"/>
                </a:prst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15341" y="6525006"/>
            <a:ext cx="2593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4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02425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88637" y="4366147"/>
            <a:ext cx="4906170" cy="3780379"/>
            <a:chOff x="853280" y="3539350"/>
            <a:chExt cx="4653574" cy="3587479"/>
          </a:xfrm>
        </p:grpSpPr>
        <p:grpSp>
          <p:nvGrpSpPr>
            <p:cNvPr id="4" name="Group 3"/>
            <p:cNvGrpSpPr/>
            <p:nvPr/>
          </p:nvGrpSpPr>
          <p:grpSpPr>
            <a:xfrm>
              <a:off x="853280" y="3539350"/>
              <a:ext cx="4653574" cy="3587479"/>
              <a:chOff x="853280" y="3539350"/>
              <a:chExt cx="4653574" cy="3587479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319351" y="3755374"/>
                <a:ext cx="2135981" cy="1314450"/>
                <a:chOff x="3131840" y="1748408"/>
                <a:chExt cx="2847975" cy="1752600"/>
              </a:xfrm>
            </p:grpSpPr>
            <p:pic>
              <p:nvPicPr>
                <p:cNvPr id="47" name="Picture 3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3131840" y="1748408"/>
                  <a:ext cx="2847975" cy="1752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8" name="Rectangle 47"/>
                <p:cNvSpPr/>
                <p:nvPr/>
              </p:nvSpPr>
              <p:spPr>
                <a:xfrm>
                  <a:off x="3138819" y="2348880"/>
                  <a:ext cx="144016" cy="60626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</p:grpSp>
          <p:sp>
            <p:nvSpPr>
              <p:cNvPr id="7" name="Rectangle 6"/>
              <p:cNvSpPr/>
              <p:nvPr/>
            </p:nvSpPr>
            <p:spPr>
              <a:xfrm>
                <a:off x="3481369" y="4971368"/>
                <a:ext cx="1728192" cy="1620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3481369" y="3755374"/>
                <a:ext cx="1728192" cy="810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4237453" y="3962593"/>
                <a:ext cx="713724" cy="301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1226478" y="5429560"/>
                <a:ext cx="2135981" cy="1395459"/>
                <a:chOff x="3131840" y="4149080"/>
                <a:chExt cx="2847975" cy="1860612"/>
              </a:xfrm>
            </p:grpSpPr>
            <p:pic>
              <p:nvPicPr>
                <p:cNvPr id="41" name="Picture 5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131840" y="4149080"/>
                  <a:ext cx="2847975" cy="1752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2" name="TextBox 41"/>
                <p:cNvSpPr txBox="1"/>
                <p:nvPr/>
              </p:nvSpPr>
              <p:spPr>
                <a:xfrm>
                  <a:off x="4499992" y="4509120"/>
                  <a:ext cx="8640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50" dirty="0">
                      <a:solidFill>
                        <a:srgbClr val="FF0000"/>
                      </a:solidFill>
                    </a:rPr>
                    <a:t>CD90, 78%</a:t>
                  </a:r>
                  <a:endParaRPr lang="en-US" sz="75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3" name="Rectangle 42"/>
                <p:cNvSpPr/>
                <p:nvPr/>
              </p:nvSpPr>
              <p:spPr>
                <a:xfrm>
                  <a:off x="3419872" y="5793668"/>
                  <a:ext cx="2304256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44" name="Rectangle 43"/>
                <p:cNvSpPr/>
                <p:nvPr/>
              </p:nvSpPr>
              <p:spPr>
                <a:xfrm>
                  <a:off x="3131840" y="4725144"/>
                  <a:ext cx="144016" cy="60626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45" name="Rectangle 44"/>
                <p:cNvSpPr/>
                <p:nvPr/>
              </p:nvSpPr>
              <p:spPr>
                <a:xfrm>
                  <a:off x="3419872" y="4164035"/>
                  <a:ext cx="2304256" cy="10801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46" name="Rectangle 45"/>
                <p:cNvSpPr/>
                <p:nvPr/>
              </p:nvSpPr>
              <p:spPr>
                <a:xfrm>
                  <a:off x="4355976" y="4365104"/>
                  <a:ext cx="951632" cy="3241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</p:grpSp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370873" y="5446416"/>
                <a:ext cx="2135981" cy="13144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2" name="Group 11"/>
              <p:cNvGrpSpPr/>
              <p:nvPr/>
            </p:nvGrpSpPr>
            <p:grpSpPr>
              <a:xfrm>
                <a:off x="1188858" y="3764071"/>
                <a:ext cx="2143448" cy="1395459"/>
                <a:chOff x="169557" y="1748408"/>
                <a:chExt cx="2857930" cy="1860612"/>
              </a:xfrm>
            </p:grpSpPr>
            <p:pic>
              <p:nvPicPr>
                <p:cNvPr id="35" name="Picture 2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179512" y="1748408"/>
                  <a:ext cx="2847975" cy="17526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36" name="TextBox 35"/>
                <p:cNvSpPr txBox="1"/>
                <p:nvPr/>
              </p:nvSpPr>
              <p:spPr>
                <a:xfrm>
                  <a:off x="1475655" y="2348880"/>
                  <a:ext cx="8640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50" dirty="0">
                      <a:solidFill>
                        <a:srgbClr val="FF0000"/>
                      </a:solidFill>
                    </a:rPr>
                    <a:t>CD146, 46%</a:t>
                  </a:r>
                  <a:endParaRPr lang="en-US" sz="75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7" name="Rectangle 36"/>
                <p:cNvSpPr/>
                <p:nvPr/>
              </p:nvSpPr>
              <p:spPr>
                <a:xfrm>
                  <a:off x="451371" y="3392996"/>
                  <a:ext cx="2304256" cy="21602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38" name="Rectangle 37"/>
                <p:cNvSpPr/>
                <p:nvPr/>
              </p:nvSpPr>
              <p:spPr>
                <a:xfrm>
                  <a:off x="463947" y="1772816"/>
                  <a:ext cx="2304256" cy="10801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39" name="Rectangle 38"/>
                <p:cNvSpPr/>
                <p:nvPr/>
              </p:nvSpPr>
              <p:spPr>
                <a:xfrm>
                  <a:off x="169557" y="2319867"/>
                  <a:ext cx="144016" cy="60626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  <p:sp>
              <p:nvSpPr>
                <p:cNvPr id="40" name="Rectangle 39"/>
                <p:cNvSpPr/>
                <p:nvPr/>
              </p:nvSpPr>
              <p:spPr>
                <a:xfrm>
                  <a:off x="1388120" y="2216987"/>
                  <a:ext cx="951632" cy="3241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350"/>
                </a:p>
              </p:txBody>
            </p:sp>
          </p:grpSp>
          <p:sp>
            <p:nvSpPr>
              <p:cNvPr id="13" name="Rectangle 12"/>
              <p:cNvSpPr/>
              <p:nvPr/>
            </p:nvSpPr>
            <p:spPr>
              <a:xfrm>
                <a:off x="1242864" y="3539350"/>
                <a:ext cx="1203544" cy="14527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1242864" y="5321548"/>
                <a:ext cx="1203544" cy="10801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3403104" y="5321548"/>
                <a:ext cx="1203544" cy="10801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438323" y="3856296"/>
                <a:ext cx="647934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50" dirty="0"/>
                  <a:t>CD146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948975" y="5429561"/>
                <a:ext cx="155730" cy="8946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985410" y="3593357"/>
                <a:ext cx="155730" cy="8946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270"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29778" y="3847073"/>
                <a:ext cx="647934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50" dirty="0"/>
                  <a:t>CD105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573860" y="5546820"/>
                <a:ext cx="559769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50" dirty="0"/>
                  <a:t>CD45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462725" y="5549542"/>
                <a:ext cx="559769" cy="3000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50" dirty="0"/>
                  <a:t>CD90</a:t>
                </a: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1998948" y="3917392"/>
                <a:ext cx="864096" cy="1115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159188" y="4129898"/>
                <a:ext cx="864096" cy="1115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139780" y="3987513"/>
                <a:ext cx="4523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tx2"/>
                    </a:solidFill>
                  </a:rPr>
                  <a:t>46%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350965" y="4095525"/>
                <a:ext cx="4523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tx2"/>
                    </a:solidFill>
                  </a:rPr>
                  <a:t>96%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557913" y="572638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tx2"/>
                    </a:solidFill>
                  </a:rPr>
                  <a:t>0.2%</a:t>
                </a: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2046110" y="5741062"/>
                <a:ext cx="864096" cy="1115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  <p:sp>
            <p:nvSpPr>
              <p:cNvPr id="28" name="AutoShape 2"/>
              <p:cNvSpPr>
                <a:spLocks noChangeAspect="1" noChangeArrowheads="1"/>
              </p:cNvSpPr>
              <p:nvPr/>
            </p:nvSpPr>
            <p:spPr bwMode="auto">
              <a:xfrm>
                <a:off x="972742" y="3628629"/>
                <a:ext cx="2135981" cy="13144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8580" tIns="34290" rIns="68580" bIns="3429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350"/>
              </a:p>
            </p:txBody>
          </p:sp>
          <p:sp>
            <p:nvSpPr>
              <p:cNvPr id="29" name="Rectangle 28"/>
              <p:cNvSpPr>
                <a:spLocks noChangeArrowheads="1"/>
              </p:cNvSpPr>
              <p:nvPr/>
            </p:nvSpPr>
            <p:spPr bwMode="auto">
              <a:xfrm rot="16200000">
                <a:off x="667492" y="6580115"/>
                <a:ext cx="625492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5pPr>
                <a:lvl6pPr marL="22860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6pPr>
                <a:lvl7pPr marL="27432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7pPr>
                <a:lvl8pPr marL="32004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8pPr>
                <a:lvl9pPr marL="36576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9pPr>
              </a:lstStyle>
              <a:p>
                <a:r>
                  <a:rPr lang="en-US" sz="1050" b="1" dirty="0"/>
                  <a:t>counts</a:t>
                </a:r>
              </a:p>
            </p:txBody>
          </p:sp>
          <p:sp>
            <p:nvSpPr>
              <p:cNvPr id="30" name="Rectangle 29"/>
              <p:cNvSpPr>
                <a:spLocks noChangeArrowheads="1"/>
              </p:cNvSpPr>
              <p:nvPr/>
            </p:nvSpPr>
            <p:spPr bwMode="auto">
              <a:xfrm>
                <a:off x="1023409" y="6895997"/>
                <a:ext cx="896399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>
                <a:defPPr>
                  <a:defRPr lang="en-US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5pPr>
                <a:lvl6pPr marL="22860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6pPr>
                <a:lvl7pPr marL="27432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7pPr>
                <a:lvl8pPr marL="32004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8pPr>
                <a:lvl9pPr marL="3657600" algn="l" defTabSz="457200" rtl="0" eaLnBrk="1" latinLnBrk="0" hangingPunct="1">
                  <a:defRPr sz="2400" kern="1200">
                    <a:solidFill>
                      <a:schemeClr val="tx1"/>
                    </a:solidFill>
                    <a:latin typeface="Arial" pitchFamily="1" charset="0"/>
                    <a:ea typeface="ＭＳ Ｐゴシック" pitchFamily="1" charset="-128"/>
                    <a:cs typeface="ＭＳ Ｐゴシック" pitchFamily="1" charset="-128"/>
                  </a:defRPr>
                </a:lvl9pPr>
              </a:lstStyle>
              <a:p>
                <a:r>
                  <a:rPr lang="en-US" sz="900" b="1" dirty="0"/>
                  <a:t>fluorescence</a:t>
                </a:r>
              </a:p>
            </p:txBody>
          </p:sp>
          <p:grpSp>
            <p:nvGrpSpPr>
              <p:cNvPr id="31" name="Group 30"/>
              <p:cNvGrpSpPr/>
              <p:nvPr/>
            </p:nvGrpSpPr>
            <p:grpSpPr>
              <a:xfrm>
                <a:off x="1077414" y="6401668"/>
                <a:ext cx="514350" cy="514350"/>
                <a:chOff x="920750" y="5638800"/>
                <a:chExt cx="685800" cy="685800"/>
              </a:xfrm>
            </p:grpSpPr>
            <p:sp>
              <p:nvSpPr>
                <p:cNvPr id="33" name="Line 79"/>
                <p:cNvSpPr>
                  <a:spLocks noChangeShapeType="1"/>
                </p:cNvSpPr>
                <p:nvPr/>
              </p:nvSpPr>
              <p:spPr bwMode="auto">
                <a:xfrm flipV="1">
                  <a:off x="920750" y="5638800"/>
                  <a:ext cx="0" cy="68580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 wrap="none" anchor="ctr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5pPr>
                  <a:lvl6pPr marL="22860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6pPr>
                  <a:lvl7pPr marL="27432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7pPr>
                  <a:lvl8pPr marL="32004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8pPr>
                  <a:lvl9pPr marL="36576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9pPr>
                </a:lstStyle>
                <a:p>
                  <a:endParaRPr lang="en-US" sz="1800"/>
                </a:p>
              </p:txBody>
            </p:sp>
            <p:sp>
              <p:nvSpPr>
                <p:cNvPr id="34" name="Line 80"/>
                <p:cNvSpPr>
                  <a:spLocks noChangeShapeType="1"/>
                </p:cNvSpPr>
                <p:nvPr/>
              </p:nvSpPr>
              <p:spPr bwMode="auto">
                <a:xfrm>
                  <a:off x="920750" y="6324600"/>
                  <a:ext cx="6858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 wrap="none" anchor="ctr">
                  <a:prstTxWarp prst="textNoShape">
                    <a:avLst/>
                  </a:prstTxWarp>
                </a:bodyPr>
                <a:lstStyle>
                  <a:defPPr>
                    <a:defRPr lang="en-US"/>
                  </a:defPPr>
                  <a:lvl1pPr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1pPr>
                  <a:lvl2pPr marL="4572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2pPr>
                  <a:lvl3pPr marL="9144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3pPr>
                  <a:lvl4pPr marL="13716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4pPr>
                  <a:lvl5pPr marL="1828800" algn="l" rtl="0" fontAlgn="base">
                    <a:spcBef>
                      <a:spcPct val="0"/>
                    </a:spcBef>
                    <a:spcAft>
                      <a:spcPct val="0"/>
                    </a:spcAft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5pPr>
                  <a:lvl6pPr marL="22860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6pPr>
                  <a:lvl7pPr marL="27432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7pPr>
                  <a:lvl8pPr marL="32004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8pPr>
                  <a:lvl9pPr marL="3657600" algn="l" defTabSz="457200" rtl="0" eaLnBrk="1" latinLnBrk="0" hangingPunct="1">
                    <a:defRPr sz="2400" kern="1200">
                      <a:solidFill>
                        <a:schemeClr val="tx1"/>
                      </a:solidFill>
                      <a:latin typeface="Arial" pitchFamily="1" charset="0"/>
                      <a:ea typeface="ＭＳ Ｐゴシック" pitchFamily="1" charset="-128"/>
                      <a:cs typeface="ＭＳ Ｐゴシック" pitchFamily="1" charset="-128"/>
                    </a:defRPr>
                  </a:lvl9pPr>
                </a:lstStyle>
                <a:p>
                  <a:endParaRPr lang="en-US" sz="1800"/>
                </a:p>
              </p:txBody>
            </p:sp>
          </p:grpSp>
          <p:sp>
            <p:nvSpPr>
              <p:cNvPr id="32" name="TextBox 31"/>
              <p:cNvSpPr txBox="1"/>
              <p:nvPr/>
            </p:nvSpPr>
            <p:spPr>
              <a:xfrm>
                <a:off x="2252592" y="5602562"/>
                <a:ext cx="4523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solidFill>
                      <a:schemeClr val="tx2"/>
                    </a:solidFill>
                  </a:rPr>
                  <a:t>78%</a:t>
                </a:r>
              </a:p>
            </p:txBody>
          </p:sp>
        </p:grpSp>
        <p:sp>
          <p:nvSpPr>
            <p:cNvPr id="5" name="Rectangle 4"/>
            <p:cNvSpPr/>
            <p:nvPr/>
          </p:nvSpPr>
          <p:spPr>
            <a:xfrm>
              <a:off x="4266307" y="5665206"/>
              <a:ext cx="864096" cy="1115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50"/>
            </a:p>
          </p:txBody>
        </p:sp>
      </p:grpSp>
      <p:pic>
        <p:nvPicPr>
          <p:cNvPr id="63" name="Picture 6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97162" y="822107"/>
            <a:ext cx="4048790" cy="3449282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1219200" y="822107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</a:t>
            </a:r>
            <a:endParaRPr lang="en-GB" dirty="0"/>
          </a:p>
        </p:txBody>
      </p:sp>
      <p:sp>
        <p:nvSpPr>
          <p:cNvPr id="65" name="TextBox 64"/>
          <p:cNvSpPr txBox="1"/>
          <p:nvPr/>
        </p:nvSpPr>
        <p:spPr>
          <a:xfrm>
            <a:off x="1188637" y="438637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I</a:t>
            </a:r>
            <a:endParaRPr lang="en-GB" dirty="0"/>
          </a:p>
        </p:txBody>
      </p:sp>
      <p:sp>
        <p:nvSpPr>
          <p:cNvPr id="66" name="TextBox 72">
            <a:extLst>
              <a:ext uri="{FF2B5EF4-FFF2-40B4-BE49-F238E27FC236}">
                <a16:creationId xmlns:a16="http://schemas.microsoft.com/office/drawing/2014/main" id="{598D48B9-6F74-E243-A0CC-17A7A31B5D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3175" y="8466301"/>
            <a:ext cx="50542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/>
            <a:r>
              <a:rPr lang="en-GB" altLang="en-US" sz="1800" dirty="0" smtClean="0">
                <a:latin typeface="+mn-lt"/>
              </a:rPr>
              <a:t>Supplementary Figure 1.</a:t>
            </a:r>
            <a:endParaRPr lang="en-GB" alt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987556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-4"/>
          <a:stretch/>
        </p:blipFill>
        <p:spPr>
          <a:xfrm>
            <a:off x="349250" y="1069258"/>
            <a:ext cx="5676900" cy="261374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16834" y="4143879"/>
            <a:ext cx="5711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Supplementary Figure 2.   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1308100" y="702384"/>
            <a:ext cx="13735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xperiment I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4133850" y="702384"/>
            <a:ext cx="1431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xperiment II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95603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581049" y="406309"/>
            <a:ext cx="5787945" cy="8523806"/>
            <a:chOff x="442678" y="391861"/>
            <a:chExt cx="5986043" cy="886346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8951" t="-6405" r="728" b="6405"/>
            <a:stretch/>
          </p:blipFill>
          <p:spPr>
            <a:xfrm>
              <a:off x="2075460" y="391861"/>
              <a:ext cx="1399333" cy="1497661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2051833" y="451960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29</a:t>
              </a:r>
              <a:endParaRPr lang="en-GB" sz="1400" dirty="0"/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3"/>
            <a:srcRect l="3863" b="6682"/>
            <a:stretch/>
          </p:blipFill>
          <p:spPr>
            <a:xfrm>
              <a:off x="521137" y="3308514"/>
              <a:ext cx="1506972" cy="1416337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/>
            <a:srcRect l="2735" b="7332"/>
            <a:stretch/>
          </p:blipFill>
          <p:spPr>
            <a:xfrm>
              <a:off x="540571" y="497609"/>
              <a:ext cx="1503305" cy="138677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613865" y="460925"/>
              <a:ext cx="6607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a</a:t>
              </a:r>
              <a:endParaRPr lang="en-GB" sz="1400" dirty="0"/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/>
            <a:srcRect l="3339" b="6635"/>
            <a:stretch/>
          </p:blipFill>
          <p:spPr>
            <a:xfrm>
              <a:off x="548311" y="1900581"/>
              <a:ext cx="1487824" cy="1391487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629105" y="1891374"/>
              <a:ext cx="6687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b</a:t>
              </a:r>
              <a:endParaRPr lang="en-GB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13865" y="3301678"/>
              <a:ext cx="6495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c</a:t>
              </a:r>
              <a:endParaRPr lang="en-GB" sz="1400" dirty="0"/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6"/>
            <a:srcRect l="2059"/>
            <a:stretch/>
          </p:blipFill>
          <p:spPr>
            <a:xfrm>
              <a:off x="507583" y="4769337"/>
              <a:ext cx="1536293" cy="139430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612209" y="4716984"/>
              <a:ext cx="6687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d</a:t>
              </a:r>
              <a:endParaRPr lang="en-GB" sz="1400" dirty="0"/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2678" y="6211085"/>
              <a:ext cx="1603628" cy="1465682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600753" y="6185532"/>
              <a:ext cx="663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e</a:t>
              </a:r>
              <a:endParaRPr lang="en-GB" sz="1400" dirty="0"/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8"/>
            <a:srcRect l="1968" r="1"/>
            <a:stretch/>
          </p:blipFill>
          <p:spPr>
            <a:xfrm>
              <a:off x="474295" y="7710203"/>
              <a:ext cx="1573593" cy="1545123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592645" y="7669878"/>
              <a:ext cx="628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9f</a:t>
              </a:r>
              <a:endParaRPr lang="en-GB" sz="1400" dirty="0"/>
            </a:p>
          </p:txBody>
        </p:sp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075460" y="1891616"/>
              <a:ext cx="1399333" cy="1399333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2049930" y="1879708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73</a:t>
              </a:r>
              <a:endParaRPr lang="en-GB" sz="1400" dirty="0"/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075460" y="3309874"/>
              <a:ext cx="1406012" cy="1406012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2067653" y="3323649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13</a:t>
              </a:r>
              <a:endParaRPr lang="en-GB" sz="1400" dirty="0"/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075460" y="4738338"/>
              <a:ext cx="1403035" cy="141038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2049934" y="4767590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105</a:t>
              </a:r>
              <a:endParaRPr lang="en-GB" sz="1400" dirty="0"/>
            </a:p>
          </p:txBody>
        </p:sp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059422" y="6176567"/>
              <a:ext cx="1467179" cy="1474821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2102320" y="6201279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90</a:t>
              </a:r>
              <a:endParaRPr lang="en-GB" sz="1400" dirty="0"/>
            </a:p>
          </p:txBody>
        </p: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075460" y="7670272"/>
              <a:ext cx="1461880" cy="1576089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2084192" y="7665953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166</a:t>
              </a:r>
              <a:endParaRPr lang="en-GB" sz="1400" dirty="0"/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514118" y="451961"/>
              <a:ext cx="1431107" cy="1423454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3513797" y="460292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44</a:t>
              </a:r>
              <a:endParaRPr lang="en-GB" sz="1400" dirty="0"/>
            </a:p>
          </p:txBody>
        </p:sp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513797" y="1891617"/>
              <a:ext cx="1435430" cy="1427992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3513797" y="1928581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56</a:t>
              </a:r>
              <a:endParaRPr lang="en-GB" sz="1400" dirty="0"/>
            </a:p>
          </p:txBody>
        </p:sp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513797" y="3350942"/>
              <a:ext cx="1376571" cy="1383972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3527200" y="3345811"/>
              <a:ext cx="5757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HLA-I</a:t>
              </a:r>
              <a:endParaRPr lang="en-GB" sz="1400" dirty="0"/>
            </a:p>
          </p:txBody>
        </p:sp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492919" y="4748484"/>
              <a:ext cx="1392746" cy="1400234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3530750" y="4740137"/>
              <a:ext cx="6206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HLA-II</a:t>
              </a:r>
              <a:endParaRPr lang="en-GB" sz="1400" dirty="0"/>
            </a:p>
          </p:txBody>
        </p:sp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462864" y="6171253"/>
              <a:ext cx="1452856" cy="143780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3513797" y="6176566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271</a:t>
              </a:r>
              <a:endParaRPr lang="en-GB" sz="1400" dirty="0"/>
            </a:p>
          </p:txBody>
        </p:sp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492919" y="7701238"/>
              <a:ext cx="1422801" cy="1545854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3523447" y="7689291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34</a:t>
              </a:r>
              <a:endParaRPr lang="en-GB" sz="1400" dirty="0"/>
            </a:p>
          </p:txBody>
        </p:sp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977968" y="430455"/>
              <a:ext cx="1444960" cy="1444960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4981202" y="435519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71</a:t>
              </a:r>
              <a:endParaRPr lang="en-GB" sz="1400" dirty="0"/>
            </a:p>
          </p:txBody>
        </p:sp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981202" y="1863360"/>
              <a:ext cx="1447519" cy="1463084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5015064" y="1869015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133</a:t>
              </a:r>
              <a:endParaRPr lang="en-GB" sz="1400" dirty="0"/>
            </a:p>
          </p:txBody>
        </p:sp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981203" y="3345812"/>
              <a:ext cx="1441725" cy="1569378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5039597" y="3351455"/>
              <a:ext cx="665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/>
                <a:t>CD146</a:t>
              </a:r>
              <a:endParaRPr lang="en-GB" sz="1400" dirty="0"/>
            </a:p>
          </p:txBody>
        </p:sp>
      </p:grpSp>
      <p:sp>
        <p:nvSpPr>
          <p:cNvPr id="50" name="TextBox 49"/>
          <p:cNvSpPr txBox="1"/>
          <p:nvPr/>
        </p:nvSpPr>
        <p:spPr>
          <a:xfrm rot="16200000">
            <a:off x="-70669" y="4483546"/>
            <a:ext cx="1075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% of Max</a:t>
            </a:r>
            <a:endParaRPr lang="en-GB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651709" y="9040233"/>
            <a:ext cx="5711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Supplementary Figure 3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858044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2376689"/>
              </p:ext>
            </p:extLst>
          </p:nvPr>
        </p:nvGraphicFramePr>
        <p:xfrm>
          <a:off x="1451509" y="793942"/>
          <a:ext cx="4687021" cy="412592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07504">
                  <a:extLst>
                    <a:ext uri="{9D8B030D-6E8A-4147-A177-3AD203B41FA5}">
                      <a16:colId xmlns:a16="http://schemas.microsoft.com/office/drawing/2014/main" val="2900000702"/>
                    </a:ext>
                  </a:extLst>
                </a:gridCol>
                <a:gridCol w="3117344">
                  <a:extLst>
                    <a:ext uri="{9D8B030D-6E8A-4147-A177-3AD203B41FA5}">
                      <a16:colId xmlns:a16="http://schemas.microsoft.com/office/drawing/2014/main" val="2714302336"/>
                    </a:ext>
                  </a:extLst>
                </a:gridCol>
                <a:gridCol w="862173">
                  <a:extLst>
                    <a:ext uri="{9D8B030D-6E8A-4147-A177-3AD203B41FA5}">
                      <a16:colId xmlns:a16="http://schemas.microsoft.com/office/drawing/2014/main" val="380915479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Marke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Nam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  <a:r>
                        <a:rPr lang="en-GB" sz="1100" dirty="0" err="1" smtClean="0">
                          <a:effectLst/>
                          <a:latin typeface="+mn-lt"/>
                          <a:ea typeface="+mn-ea"/>
                          <a:cs typeface="+mn-cs"/>
                        </a:rPr>
                        <a:t>ve</a:t>
                      </a: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 Cell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 [% , Range]</a:t>
                      </a:r>
                      <a:r>
                        <a:rPr lang="en-GB" sz="1100" baseline="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40373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9a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alpha 1 (ITGA1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25-6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02260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9b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alpha 2 (ITGA2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70-9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010749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9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alpha 3 (ITGA3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52-8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454045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9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Integrin alpha 4 (ITGA4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0.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70902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CD49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alpha 5 (ITGA5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67-9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401095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9f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alpha 6 (ITGA6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27-6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261288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2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Integrin  beta 1 (ITGB1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34-6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408000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7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Ecto-5</a:t>
                      </a:r>
                      <a:r>
                        <a:rPr lang="en-GB" sz="1100" dirty="0">
                          <a:effectLst/>
                        </a:rPr>
                        <a:t>’-</a:t>
                      </a:r>
                      <a:r>
                        <a:rPr lang="en-GB" sz="1100" dirty="0" smtClean="0">
                          <a:effectLst/>
                        </a:rPr>
                        <a:t>nucleotidase </a:t>
                      </a:r>
                      <a:r>
                        <a:rPr lang="en-GB" sz="1100" dirty="0">
                          <a:effectLst/>
                        </a:rPr>
                        <a:t>(NT5E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68-9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1475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1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Alanyl</a:t>
                      </a:r>
                      <a:r>
                        <a:rPr lang="en-GB" sz="1100" dirty="0">
                          <a:effectLst/>
                        </a:rPr>
                        <a:t> </a:t>
                      </a:r>
                      <a:r>
                        <a:rPr lang="en-GB" sz="1100" dirty="0" smtClean="0">
                          <a:effectLst/>
                        </a:rPr>
                        <a:t>Aminopeptidase</a:t>
                      </a:r>
                      <a:r>
                        <a:rPr lang="en-GB" sz="1100" baseline="0" dirty="0" smtClean="0">
                          <a:effectLst/>
                        </a:rPr>
                        <a:t> N</a:t>
                      </a:r>
                      <a:r>
                        <a:rPr lang="en-GB" sz="1100" dirty="0" smtClean="0">
                          <a:effectLst/>
                        </a:rPr>
                        <a:t> </a:t>
                      </a:r>
                      <a:r>
                        <a:rPr lang="en-GB" sz="1100" dirty="0">
                          <a:effectLst/>
                        </a:rPr>
                        <a:t>(ANPEP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99-10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108521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10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err="1">
                          <a:effectLst/>
                        </a:rPr>
                        <a:t>Endoglin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13-7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83537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9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hy-1 cell surface antige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76-9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68930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16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Activate Leukocyte Cell Adhesion Molecule (ALCAM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86-9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68417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4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Hyaluronan Recepto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99-10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776178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5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Neural Cell Adhesion Molecule 1 (NCAM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29-3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137859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HLA-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r>
                        <a:rPr lang="en-GB" sz="1100" dirty="0" smtClean="0">
                          <a:effectLst/>
                        </a:rPr>
                        <a:t>Human Leukocyte</a:t>
                      </a:r>
                      <a:r>
                        <a:rPr lang="en-GB" sz="1100" baseline="0" dirty="0" smtClean="0">
                          <a:effectLst/>
                        </a:rPr>
                        <a:t> Antigen Type 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95-10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991998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HLA-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r>
                        <a:rPr lang="en-GB" sz="1100" dirty="0" smtClean="0">
                          <a:effectLst/>
                        </a:rPr>
                        <a:t>Human Leukocyte</a:t>
                      </a:r>
                      <a:r>
                        <a:rPr lang="en-GB" sz="1100" baseline="0" dirty="0" smtClean="0">
                          <a:effectLst/>
                        </a:rPr>
                        <a:t> Antigen Type 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0-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283225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27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p75</a:t>
                      </a:r>
                      <a:r>
                        <a:rPr lang="en-GB" sz="1100" baseline="0" dirty="0" smtClean="0">
                          <a:effectLst/>
                        </a:rPr>
                        <a:t> Low Affinity </a:t>
                      </a:r>
                      <a:r>
                        <a:rPr lang="en-GB" sz="1100" dirty="0" smtClean="0">
                          <a:effectLst/>
                        </a:rPr>
                        <a:t>Nerve </a:t>
                      </a:r>
                      <a:r>
                        <a:rPr lang="en-GB" sz="1100" dirty="0">
                          <a:effectLst/>
                        </a:rPr>
                        <a:t>Growth Factor Recepto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6-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249772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3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r>
                        <a:rPr lang="en-GB" sz="1100" dirty="0" smtClean="0">
                          <a:effectLst/>
                        </a:rPr>
                        <a:t>Transmembrane Glycoprotein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0-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943399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7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Transferrin Receptor (TFRC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+mn-lt"/>
                          <a:ea typeface="+mn-ea"/>
                          <a:cs typeface="+mn-cs"/>
                        </a:rPr>
                        <a:t>6-1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977372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13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Prominin-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0-1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451466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CD14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Melanoma Cell Adhesion </a:t>
                      </a:r>
                      <a:r>
                        <a:rPr lang="en-GB" sz="1100" dirty="0" smtClean="0">
                          <a:effectLst/>
                        </a:rPr>
                        <a:t>Molecule </a:t>
                      </a:r>
                      <a:r>
                        <a:rPr lang="en-GB" sz="1100" dirty="0">
                          <a:effectLst/>
                        </a:rPr>
                        <a:t>(MCAM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1-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9610601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288531" y="5206131"/>
            <a:ext cx="501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Supplementary Figure 4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04014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D6703FA-F31D-5C4D-AE43-A3F1B170155B}"/>
              </a:ext>
            </a:extLst>
          </p:cNvPr>
          <p:cNvSpPr/>
          <p:nvPr/>
        </p:nvSpPr>
        <p:spPr>
          <a:xfrm>
            <a:off x="742332" y="8710452"/>
            <a:ext cx="54382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/>
              <a:t>Supplementary Figure 5. 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37615A-9835-1246-A44F-BC495AF38754}"/>
              </a:ext>
            </a:extLst>
          </p:cNvPr>
          <p:cNvSpPr txBox="1"/>
          <p:nvPr/>
        </p:nvSpPr>
        <p:spPr>
          <a:xfrm>
            <a:off x="672120" y="400795"/>
            <a:ext cx="376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2F6AC3-A4F7-704A-B2E2-96E6525EFFEB}"/>
              </a:ext>
            </a:extLst>
          </p:cNvPr>
          <p:cNvSpPr txBox="1"/>
          <p:nvPr/>
        </p:nvSpPr>
        <p:spPr>
          <a:xfrm>
            <a:off x="648908" y="3519675"/>
            <a:ext cx="439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A6B46CF-A512-3749-9511-1259EEF100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438" t="12598" r="438"/>
          <a:stretch/>
        </p:blipFill>
        <p:spPr>
          <a:xfrm>
            <a:off x="1087914" y="3681965"/>
            <a:ext cx="4853111" cy="293652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3343" y="771065"/>
            <a:ext cx="5410565" cy="2593366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>
            <a:off x="1287367" y="7041402"/>
            <a:ext cx="4711627" cy="1508524"/>
            <a:chOff x="1457485" y="5484041"/>
            <a:chExt cx="4711627" cy="1508524"/>
          </a:xfrm>
        </p:grpSpPr>
        <p:pic>
          <p:nvPicPr>
            <p:cNvPr id="10" name="Picture 9" descr="A picture containing map&#10;&#10;Description automatically generated">
              <a:extLst>
                <a:ext uri="{FF2B5EF4-FFF2-40B4-BE49-F238E27FC236}">
                  <a16:creationId xmlns:a16="http://schemas.microsoft.com/office/drawing/2014/main" id="{B281E691-FE81-4C3E-BFB3-F676B48165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07" t="7819" r="2579" b="12059"/>
            <a:stretch/>
          </p:blipFill>
          <p:spPr>
            <a:xfrm>
              <a:off x="4548338" y="6213439"/>
              <a:ext cx="785735" cy="779126"/>
            </a:xfrm>
            <a:prstGeom prst="rect">
              <a:avLst/>
            </a:prstGeom>
          </p:spPr>
        </p:pic>
        <p:sp>
          <p:nvSpPr>
            <p:cNvPr id="11" name="Arrow: Pentagon 6">
              <a:extLst>
                <a:ext uri="{FF2B5EF4-FFF2-40B4-BE49-F238E27FC236}">
                  <a16:creationId xmlns:a16="http://schemas.microsoft.com/office/drawing/2014/main" id="{263A2835-45DD-49A9-83B8-C50BF3C62B5B}"/>
                </a:ext>
              </a:extLst>
            </p:cNvPr>
            <p:cNvSpPr/>
            <p:nvPr/>
          </p:nvSpPr>
          <p:spPr>
            <a:xfrm>
              <a:off x="4226056" y="5853728"/>
              <a:ext cx="1163820" cy="194123"/>
            </a:xfrm>
            <a:prstGeom prst="homePlate">
              <a:avLst/>
            </a:prstGeom>
            <a:gradFill flip="none" rotWithShape="1">
              <a:gsLst>
                <a:gs pos="0">
                  <a:schemeClr val="bg1">
                    <a:lumMod val="95000"/>
                  </a:schemeClr>
                </a:gs>
                <a:gs pos="35000">
                  <a:schemeClr val="bg1">
                    <a:lumMod val="95000"/>
                  </a:schemeClr>
                </a:gs>
                <a:gs pos="100000">
                  <a:schemeClr val="accent1">
                    <a:lumMod val="100000"/>
                  </a:scheme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8B62E18-359D-4902-8267-52B931A3E617}"/>
                </a:ext>
              </a:extLst>
            </p:cNvPr>
            <p:cNvSpPr txBox="1"/>
            <p:nvPr/>
          </p:nvSpPr>
          <p:spPr>
            <a:xfrm>
              <a:off x="3910178" y="6384306"/>
              <a:ext cx="845654" cy="367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/>
                <a:t>LPS -/+</a:t>
              </a:r>
            </a:p>
            <a:p>
              <a:pPr algn="ctr"/>
              <a:r>
                <a:rPr lang="en-GB" sz="1050" dirty="0"/>
                <a:t>MSC-/+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DEBC922-E2DC-4415-9AF1-EE4560D339FF}"/>
                </a:ext>
              </a:extLst>
            </p:cNvPr>
            <p:cNvSpPr txBox="1"/>
            <p:nvPr/>
          </p:nvSpPr>
          <p:spPr>
            <a:xfrm>
              <a:off x="5080645" y="5484041"/>
              <a:ext cx="921009" cy="224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/>
                <a:t>24 hour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DC9CA73-AB89-4249-A2F3-B8C2AE1DA428}"/>
                </a:ext>
              </a:extLst>
            </p:cNvPr>
            <p:cNvSpPr txBox="1"/>
            <p:nvPr/>
          </p:nvSpPr>
          <p:spPr>
            <a:xfrm>
              <a:off x="4913189" y="6122413"/>
              <a:ext cx="1255923" cy="224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/>
                <a:t>Assess for cytokines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BCF90C7C-A7FA-40F2-A123-4640A609F3DC}"/>
                </a:ext>
              </a:extLst>
            </p:cNvPr>
            <p:cNvCxnSpPr>
              <a:cxnSpLocks/>
              <a:stCxn id="11" idx="1"/>
            </p:cNvCxnSpPr>
            <p:nvPr/>
          </p:nvCxnSpPr>
          <p:spPr>
            <a:xfrm flipH="1" flipV="1">
              <a:off x="1820849" y="5946554"/>
              <a:ext cx="2405207" cy="4236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3364FCED-9204-4C30-92DE-5E81EDE757D9}"/>
                </a:ext>
              </a:extLst>
            </p:cNvPr>
            <p:cNvCxnSpPr>
              <a:cxnSpLocks/>
            </p:cNvCxnSpPr>
            <p:nvPr/>
          </p:nvCxnSpPr>
          <p:spPr>
            <a:xfrm>
              <a:off x="2331200" y="5726264"/>
              <a:ext cx="0" cy="396149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D41C86-314D-4589-888E-3A70EF53627A}"/>
                </a:ext>
              </a:extLst>
            </p:cNvPr>
            <p:cNvSpPr txBox="1"/>
            <p:nvPr/>
          </p:nvSpPr>
          <p:spPr>
            <a:xfrm>
              <a:off x="1457485" y="5524677"/>
              <a:ext cx="921009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THP1</a:t>
              </a:r>
            </a:p>
            <a:p>
              <a:r>
                <a:rPr lang="en-GB" sz="1050" dirty="0" smtClean="0"/>
                <a:t>(RPMI+PMA)</a:t>
              </a:r>
              <a:endParaRPr lang="en-GB" sz="105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B129637-499A-4A3F-8016-7A53C4F1558D}"/>
                </a:ext>
              </a:extLst>
            </p:cNvPr>
            <p:cNvSpPr txBox="1"/>
            <p:nvPr/>
          </p:nvSpPr>
          <p:spPr>
            <a:xfrm>
              <a:off x="2363026" y="5689323"/>
              <a:ext cx="17306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 smtClean="0"/>
                <a:t>(RPMI </a:t>
              </a:r>
              <a:r>
                <a:rPr lang="en-GB" sz="1050" dirty="0"/>
                <a:t>w/o </a:t>
              </a:r>
              <a:r>
                <a:rPr lang="en-GB" sz="1050" dirty="0" smtClean="0"/>
                <a:t>PMA)</a:t>
              </a:r>
              <a:endParaRPr lang="en-GB" sz="1050" dirty="0"/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BEBB1B91-6CDD-4FF6-B178-16F5CD3773A4}"/>
                </a:ext>
              </a:extLst>
            </p:cNvPr>
            <p:cNvCxnSpPr>
              <a:cxnSpLocks/>
            </p:cNvCxnSpPr>
            <p:nvPr/>
          </p:nvCxnSpPr>
          <p:spPr>
            <a:xfrm>
              <a:off x="5475424" y="5726264"/>
              <a:ext cx="0" cy="396149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29ED8D3-61DB-4B81-A4E5-8F46C91B8C15}"/>
                </a:ext>
              </a:extLst>
            </p:cNvPr>
            <p:cNvSpPr txBox="1"/>
            <p:nvPr/>
          </p:nvSpPr>
          <p:spPr>
            <a:xfrm>
              <a:off x="1602798" y="6158462"/>
              <a:ext cx="31530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 smtClean="0"/>
                <a:t>D0               D3                                                           D8</a:t>
              </a:r>
              <a:endParaRPr lang="en-GB" sz="105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7D41C86-314D-4589-888E-3A70EF53627A}"/>
                </a:ext>
              </a:extLst>
            </p:cNvPr>
            <p:cNvSpPr txBox="1"/>
            <p:nvPr/>
          </p:nvSpPr>
          <p:spPr>
            <a:xfrm>
              <a:off x="3916224" y="5570433"/>
              <a:ext cx="9210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THP1 </a:t>
              </a:r>
              <a:r>
                <a:rPr lang="en-GB" sz="1050" b="1" dirty="0" err="1" smtClean="0"/>
                <a:t>Mɸ</a:t>
              </a:r>
              <a:endParaRPr lang="en-GB" sz="1050" dirty="0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649176" y="675846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546285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4024" y="641349"/>
            <a:ext cx="4849113" cy="422529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19150" y="558800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r>
              <a:rPr lang="en-GB" dirty="0" smtClean="0"/>
              <a:t>.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4574" y="4872997"/>
            <a:ext cx="4898563" cy="434085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63983" y="462915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r>
              <a:rPr lang="en-GB" dirty="0" smtClean="0"/>
              <a:t>.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264296" y="9307592"/>
            <a:ext cx="2768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 6. 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1663700" y="743466"/>
            <a:ext cx="1369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hMS vs hESC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1582328" y="4988331"/>
            <a:ext cx="1831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hMS vs </a:t>
            </a:r>
            <a:r>
              <a:rPr lang="en-GB" dirty="0" err="1" smtClean="0"/>
              <a:t>hBM</a:t>
            </a:r>
            <a:r>
              <a:rPr lang="en-GB" dirty="0" smtClean="0"/>
              <a:t> MSC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87562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412147" y="1278712"/>
            <a:ext cx="5841451" cy="2836879"/>
            <a:chOff x="-1057901" y="2418996"/>
            <a:chExt cx="9219084" cy="5068007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057901" y="2418996"/>
              <a:ext cx="8973802" cy="5068007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89444" y="4474155"/>
              <a:ext cx="1171739" cy="2467319"/>
            </a:xfrm>
            <a:prstGeom prst="rect">
              <a:avLst/>
            </a:prstGeom>
          </p:spPr>
        </p:pic>
      </p:grpSp>
      <p:sp>
        <p:nvSpPr>
          <p:cNvPr id="2" name="TextBox 1"/>
          <p:cNvSpPr txBox="1"/>
          <p:nvPr/>
        </p:nvSpPr>
        <p:spPr>
          <a:xfrm>
            <a:off x="446519" y="8004843"/>
            <a:ext cx="2680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7.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57916" y="538972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.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627083" y="426681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r>
              <a:rPr lang="en-GB" dirty="0" smtClean="0"/>
              <a:t>.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1620397" y="783123"/>
            <a:ext cx="1166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hMS &gt; hESC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1278329" y="4474155"/>
            <a:ext cx="1166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 smtClean="0"/>
              <a:t>hMS</a:t>
            </a:r>
            <a:r>
              <a:rPr lang="en-GB" sz="1600" dirty="0" smtClean="0"/>
              <a:t> &lt; </a:t>
            </a:r>
            <a:r>
              <a:rPr lang="en-GB" sz="1600" dirty="0" err="1" smtClean="0"/>
              <a:t>hESC</a:t>
            </a:r>
            <a:endParaRPr lang="en-GB" sz="1600" dirty="0"/>
          </a:p>
        </p:txBody>
      </p:sp>
      <p:grpSp>
        <p:nvGrpSpPr>
          <p:cNvPr id="10" name="Group 9"/>
          <p:cNvGrpSpPr/>
          <p:nvPr/>
        </p:nvGrpSpPr>
        <p:grpSpPr>
          <a:xfrm>
            <a:off x="690128" y="4841621"/>
            <a:ext cx="5563470" cy="2931080"/>
            <a:chOff x="-1067428" y="2438049"/>
            <a:chExt cx="8992855" cy="502990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067428" y="2438049"/>
              <a:ext cx="8992855" cy="502990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45832" y="3451734"/>
              <a:ext cx="1114581" cy="34009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753955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3883" y="4779072"/>
            <a:ext cx="4737060" cy="436121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916" y="627997"/>
            <a:ext cx="5857888" cy="397859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76037" y="9194488"/>
            <a:ext cx="2627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8. 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57916" y="538972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.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76036" y="4644721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r>
              <a:rPr lang="en-GB" dirty="0" smtClean="0"/>
              <a:t>.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3003398" y="631744"/>
            <a:ext cx="1166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hMS &gt; hESC</a:t>
            </a:r>
            <a:endParaRPr lang="en-GB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2919145" y="4724873"/>
            <a:ext cx="11669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 smtClean="0"/>
              <a:t>hMS</a:t>
            </a:r>
            <a:r>
              <a:rPr lang="en-GB" sz="1600" dirty="0" smtClean="0"/>
              <a:t> &lt; </a:t>
            </a:r>
            <a:r>
              <a:rPr lang="en-GB" sz="1600" dirty="0" err="1" smtClean="0"/>
              <a:t>hESC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287196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20</TotalTime>
  <Words>542</Words>
  <Application>Microsoft Office PowerPoint</Application>
  <PresentationFormat>A4 Paper (210x297 mm)</PresentationFormat>
  <Paragraphs>281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3" baseType="lpstr">
      <vt:lpstr>ＭＳ Ｐゴシック</vt:lpstr>
      <vt:lpstr>Arial</vt:lpstr>
      <vt:lpstr>ArialMT</vt:lpstr>
      <vt:lpstr>Calibri</vt:lpstr>
      <vt:lpstr>Calibri Light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De Sousa</dc:creator>
  <cp:lastModifiedBy>Paul De Sousa</cp:lastModifiedBy>
  <cp:revision>259</cp:revision>
  <dcterms:created xsi:type="dcterms:W3CDTF">2023-02-14T08:49:59Z</dcterms:created>
  <dcterms:modified xsi:type="dcterms:W3CDTF">2023-10-11T16:05:19Z</dcterms:modified>
</cp:coreProperties>
</file>